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57" r:id="rId3"/>
    <p:sldId id="258" r:id="rId4"/>
    <p:sldId id="259" r:id="rId5"/>
    <p:sldId id="260" r:id="rId6"/>
    <p:sldId id="261" r:id="rId7"/>
    <p:sldId id="264" r:id="rId8"/>
    <p:sldId id="265" r:id="rId9"/>
    <p:sldId id="266" r:id="rId10"/>
    <p:sldId id="262" r:id="rId11"/>
    <p:sldId id="263" r:id="rId1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64" d="100"/>
          <a:sy n="64" d="100"/>
        </p:scale>
        <p:origin x="-1470" y="-102"/>
      </p:cViewPr>
      <p:guideLst>
        <p:guide orient="horz" pos="4319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9775-11E6-4C64-9B5F-AC0A277BA08D}" type="datetimeFigureOut">
              <a:rPr lang="en-US" smtClean="0"/>
              <a:pPr/>
              <a:t>8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BCAC-F38E-4896-80D8-E09D889A0CA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9775-11E6-4C64-9B5F-AC0A277BA08D}" type="datetimeFigureOut">
              <a:rPr lang="en-US" smtClean="0"/>
              <a:pPr/>
              <a:t>8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BCAC-F38E-4896-80D8-E09D889A0CA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9775-11E6-4C64-9B5F-AC0A277BA08D}" type="datetimeFigureOut">
              <a:rPr lang="en-US" smtClean="0"/>
              <a:pPr/>
              <a:t>8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BCAC-F38E-4896-80D8-E09D889A0CA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9775-11E6-4C64-9B5F-AC0A277BA08D}" type="datetimeFigureOut">
              <a:rPr lang="en-US" smtClean="0"/>
              <a:pPr/>
              <a:t>8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BCAC-F38E-4896-80D8-E09D889A0CA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9775-11E6-4C64-9B5F-AC0A277BA08D}" type="datetimeFigureOut">
              <a:rPr lang="en-US" smtClean="0"/>
              <a:pPr/>
              <a:t>8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BCAC-F38E-4896-80D8-E09D889A0CA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9775-11E6-4C64-9B5F-AC0A277BA08D}" type="datetimeFigureOut">
              <a:rPr lang="en-US" smtClean="0"/>
              <a:pPr/>
              <a:t>8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BCAC-F38E-4896-80D8-E09D889A0CA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9775-11E6-4C64-9B5F-AC0A277BA08D}" type="datetimeFigureOut">
              <a:rPr lang="en-US" smtClean="0"/>
              <a:pPr/>
              <a:t>8/1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BCAC-F38E-4896-80D8-E09D889A0CA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9775-11E6-4C64-9B5F-AC0A277BA08D}" type="datetimeFigureOut">
              <a:rPr lang="en-US" smtClean="0"/>
              <a:pPr/>
              <a:t>8/1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BCAC-F38E-4896-80D8-E09D889A0CA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9775-11E6-4C64-9B5F-AC0A277BA08D}" type="datetimeFigureOut">
              <a:rPr lang="en-US" smtClean="0"/>
              <a:pPr/>
              <a:t>8/1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BCAC-F38E-4896-80D8-E09D889A0CA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9775-11E6-4C64-9B5F-AC0A277BA08D}" type="datetimeFigureOut">
              <a:rPr lang="en-US" smtClean="0"/>
              <a:pPr/>
              <a:t>8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BCAC-F38E-4896-80D8-E09D889A0CA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9775-11E6-4C64-9B5F-AC0A277BA08D}" type="datetimeFigureOut">
              <a:rPr lang="en-US" smtClean="0"/>
              <a:pPr/>
              <a:t>8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BCAC-F38E-4896-80D8-E09D889A0CA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039775-11E6-4C64-9B5F-AC0A277BA08D}" type="datetimeFigureOut">
              <a:rPr lang="en-US" smtClean="0"/>
              <a:pPr/>
              <a:t>8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83BCAC-F38E-4896-80D8-E09D889A0CA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. 4 Image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Old Mice - </a:t>
            </a:r>
            <a:r>
              <a:rPr lang="en-US" sz="3200" dirty="0" err="1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pJNK</a:t>
            </a:r>
            <a:endParaRPr lang="en-US" sz="3200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122" name="Picture 2" descr="C:\Users\Harsh\Desktop\PLoS\Uncropped Images\Old - pJNK.tif"/>
          <p:cNvPicPr>
            <a:picLocks noChangeAspect="1" noChangeArrowheads="1"/>
          </p:cNvPicPr>
          <p:nvPr/>
        </p:nvPicPr>
        <p:blipFill>
          <a:blip r:embed="rId2" cstate="print"/>
          <a:stretch>
            <a:fillRect/>
          </a:stretch>
        </p:blipFill>
        <p:spPr bwMode="auto">
          <a:xfrm>
            <a:off x="1219200" y="1447800"/>
            <a:ext cx="6667500" cy="50101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Old Mice - </a:t>
            </a:r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JNK</a:t>
            </a:r>
            <a:endParaRPr lang="en-US" sz="3200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99" name="Picture 3" descr="C:\Users\Harsh\Desktop\PLoS\Uncropped Images\Old - JNK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85938" y="1458913"/>
            <a:ext cx="5572125" cy="3940175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Young Mice - </a:t>
            </a:r>
            <a:r>
              <a:rPr lang="en-US" sz="3200" dirty="0" err="1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pIRS</a:t>
            </a:r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 Y</a:t>
            </a:r>
            <a:r>
              <a:rPr lang="en-US" sz="3200" baseline="300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612</a:t>
            </a:r>
            <a:endParaRPr lang="en-US" sz="3200" baseline="30000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71600" y="1447800"/>
            <a:ext cx="7067550" cy="520065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143000"/>
          </a:xfrm>
        </p:spPr>
        <p:txBody>
          <a:bodyPr>
            <a:normAutofit/>
          </a:bodyPr>
          <a:lstStyle/>
          <a:p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Young Mice </a:t>
            </a:r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– </a:t>
            </a:r>
            <a:r>
              <a:rPr lang="en-US" sz="3200" dirty="0" err="1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pIRS</a:t>
            </a:r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 S</a:t>
            </a:r>
            <a:r>
              <a:rPr lang="en-US" sz="3200" baseline="300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307</a:t>
            </a:r>
            <a:endParaRPr lang="en-US" sz="3200" baseline="30000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38200" y="990600"/>
            <a:ext cx="7488936" cy="5616702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 l="3333" t="5456" r="2000" b="3675"/>
          <a:stretch>
            <a:fillRect/>
          </a:stretch>
        </p:blipFill>
        <p:spPr bwMode="auto">
          <a:xfrm>
            <a:off x="1600200" y="1676400"/>
            <a:ext cx="5410200" cy="3886200"/>
          </a:xfrm>
          <a:prstGeom prst="rect">
            <a:avLst/>
          </a:prstGeom>
          <a:noFill/>
        </p:spPr>
      </p:pic>
      <p:sp>
        <p:nvSpPr>
          <p:cNvPr id="5" name="Rectangle 4"/>
          <p:cNvSpPr/>
          <p:nvPr/>
        </p:nvSpPr>
        <p:spPr>
          <a:xfrm>
            <a:off x="2438400" y="533400"/>
            <a:ext cx="3256597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ea typeface="+mj-ea"/>
                <a:cs typeface="Times New Roman" pitchFamily="18" charset="0"/>
              </a:rPr>
              <a:t>Young Mice – </a:t>
            </a:r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ea typeface="+mj-ea"/>
                <a:cs typeface="Times New Roman" pitchFamily="18" charset="0"/>
              </a:rPr>
              <a:t>IRS</a:t>
            </a:r>
            <a:endParaRPr 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Young Mice - </a:t>
            </a:r>
            <a:r>
              <a:rPr lang="en-US" sz="3200" dirty="0" err="1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pJNK</a:t>
            </a:r>
            <a:endParaRPr lang="en-US" sz="3200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23974" y="1600200"/>
            <a:ext cx="6496050" cy="4876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Young Mice - </a:t>
            </a:r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JNK</a:t>
            </a:r>
            <a:endParaRPr lang="en-US" sz="3200" dirty="0">
              <a:solidFill>
                <a:srgbClr val="00206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30923" y="1647092"/>
            <a:ext cx="6362700" cy="47625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Old Mice - </a:t>
            </a:r>
            <a:r>
              <a:rPr lang="en-US" sz="3200" dirty="0" err="1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pIRS</a:t>
            </a:r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 Y</a:t>
            </a:r>
            <a:r>
              <a:rPr lang="en-US" sz="3200" baseline="300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612</a:t>
            </a:r>
          </a:p>
        </p:txBody>
      </p:sp>
      <p:pic>
        <p:nvPicPr>
          <p:cNvPr id="1026" name="Picture 2" descr="C:\Users\Harsh\Desktop\PLoS\Uncropped Images\Old - pIRS Y612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34950" y="3152775"/>
            <a:ext cx="8672513" cy="55245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Old Mice - </a:t>
            </a:r>
            <a:r>
              <a:rPr lang="en-US" sz="3200" dirty="0" err="1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pIRS</a:t>
            </a:r>
            <a:r>
              <a:rPr lang="en-US" sz="32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 S</a:t>
            </a:r>
            <a:r>
              <a:rPr lang="en-US" sz="3200" baseline="30000" dirty="0" smtClean="0">
                <a:solidFill>
                  <a:srgbClr val="002060"/>
                </a:solidFill>
                <a:latin typeface="Times New Roman" pitchFamily="18" charset="0"/>
                <a:cs typeface="Times New Roman" pitchFamily="18" charset="0"/>
              </a:rPr>
              <a:t>307</a:t>
            </a:r>
          </a:p>
        </p:txBody>
      </p:sp>
      <p:pic>
        <p:nvPicPr>
          <p:cNvPr id="2051" name="Picture 3" descr="C:\Users\Harsh\Desktop\PLoS\Uncropped Images\Old - pIRS S307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52600" y="2971800"/>
            <a:ext cx="5584825" cy="541337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 txBox="1">
            <a:spLocks/>
          </p:cNvSpPr>
          <p:nvPr/>
        </p:nvSpPr>
        <p:spPr>
          <a:xfrm>
            <a:off x="457200" y="30480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Old Mice - IRS</a:t>
            </a:r>
            <a:endParaRPr kumimoji="0" lang="en-US" sz="3200" b="0" i="0" u="none" strike="noStrike" kern="1200" cap="none" spc="0" normalizeH="0" baseline="30000" noProof="0" dirty="0" smtClean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  <p:pic>
        <p:nvPicPr>
          <p:cNvPr id="3075" name="Picture 3" descr="C:\Users\Harsh\Desktop\PLoS\Uncropped Images\Old - IRS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65250" y="3148013"/>
            <a:ext cx="6411913" cy="560387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48</Words>
  <Application>Microsoft Office PowerPoint</Application>
  <PresentationFormat>On-screen Show (4:3)</PresentationFormat>
  <Paragraphs>11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Fig. 4 Images</vt:lpstr>
      <vt:lpstr>Young Mice - pIRS Y612</vt:lpstr>
      <vt:lpstr>Young Mice – pIRS S307</vt:lpstr>
      <vt:lpstr>Slide 4</vt:lpstr>
      <vt:lpstr>Young Mice - pJNK</vt:lpstr>
      <vt:lpstr>Young Mice - JNK</vt:lpstr>
      <vt:lpstr>Old Mice - pIRS Y612</vt:lpstr>
      <vt:lpstr>Old Mice - pIRS S307</vt:lpstr>
      <vt:lpstr>Slide 9</vt:lpstr>
      <vt:lpstr>Old Mice - pJNK</vt:lpstr>
      <vt:lpstr>Old Mice - JNK</vt:lpstr>
    </vt:vector>
  </TitlesOfParts>
  <Company>School of Pharmac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arsh</dc:creator>
  <cp:lastModifiedBy>Harsh</cp:lastModifiedBy>
  <cp:revision>2</cp:revision>
  <dcterms:created xsi:type="dcterms:W3CDTF">2014-08-13T05:32:50Z</dcterms:created>
  <dcterms:modified xsi:type="dcterms:W3CDTF">2014-08-13T06:28:56Z</dcterms:modified>
</cp:coreProperties>
</file>